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821738" cy="6858000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2268" y="-114"/>
      </p:cViewPr>
      <p:guideLst>
        <p:guide orient="horz" pos="2160"/>
        <p:guide pos="277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nolo\Documents\My%20Dropbox\Paper%20HIP%20HOP\Figuras%20individuales\Fenotipos%20HOP%20(3A,%203B,%203C,%20S3,%205B,%20S4A,%20S4B,%205D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nolo\Documents\My%20Dropbox\Paper%20HIP%20HOP\Figuras%20individuales\Fenotipos%20HOP%20(3A,%203B,%203C,%20S3,%205B,%20S4A,%20S4B,%205D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ES_tradnl"/>
  <c:chart>
    <c:plotArea>
      <c:layout>
        <c:manualLayout>
          <c:layoutTarget val="inner"/>
          <c:xMode val="edge"/>
          <c:yMode val="edge"/>
          <c:x val="0.16603082461737076"/>
          <c:y val="4.4858679665530893E-2"/>
          <c:w val="0.69880902674590295"/>
          <c:h val="0.74671848104088823"/>
        </c:manualLayout>
      </c:layout>
      <c:barChart>
        <c:barDir val="col"/>
        <c:grouping val="clustered"/>
        <c:ser>
          <c:idx val="0"/>
          <c:order val="0"/>
          <c:tx>
            <c:v>24 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1!$D$29:$D$33</c:f>
              <c:strCache>
                <c:ptCount val="5"/>
                <c:pt idx="0">
                  <c:v>BSC1</c:v>
                </c:pt>
                <c:pt idx="1">
                  <c:v>YOL164W </c:v>
                </c:pt>
                <c:pt idx="2">
                  <c:v>RPL40A</c:v>
                </c:pt>
                <c:pt idx="3">
                  <c:v>VPS27</c:v>
                </c:pt>
                <c:pt idx="4">
                  <c:v>BRE5</c:v>
                </c:pt>
              </c:strCache>
            </c:strRef>
          </c:cat>
          <c:val>
            <c:numRef>
              <c:f>Sheet1!$E$29:$E$33</c:f>
              <c:numCache>
                <c:formatCode>0.00</c:formatCode>
                <c:ptCount val="5"/>
                <c:pt idx="0">
                  <c:v>0.85201793721973162</c:v>
                </c:pt>
                <c:pt idx="1">
                  <c:v>0.93946188340807324</c:v>
                </c:pt>
                <c:pt idx="2">
                  <c:v>0.73766816143497771</c:v>
                </c:pt>
                <c:pt idx="3">
                  <c:v>0.75560538116591935</c:v>
                </c:pt>
                <c:pt idx="4">
                  <c:v>0.83632286995515659</c:v>
                </c:pt>
              </c:numCache>
            </c:numRef>
          </c:val>
        </c:ser>
        <c:ser>
          <c:idx val="1"/>
          <c:order val="1"/>
          <c:tx>
            <c:v>21 days</c:v>
          </c:tx>
          <c:spPr>
            <a:solidFill>
              <a:schemeClr val="tx1"/>
            </a:solidFill>
          </c:spPr>
          <c:cat>
            <c:strRef>
              <c:f>Sheet1!$D$29:$D$33</c:f>
              <c:strCache>
                <c:ptCount val="5"/>
                <c:pt idx="0">
                  <c:v>BSC1</c:v>
                </c:pt>
                <c:pt idx="1">
                  <c:v>YOL164W </c:v>
                </c:pt>
                <c:pt idx="2">
                  <c:v>RPL40A</c:v>
                </c:pt>
                <c:pt idx="3">
                  <c:v>VPS27</c:v>
                </c:pt>
                <c:pt idx="4">
                  <c:v>BRE5</c:v>
                </c:pt>
              </c:strCache>
            </c:strRef>
          </c:cat>
          <c:val>
            <c:numRef>
              <c:f>Sheet1!$F$29:$F$33</c:f>
              <c:numCache>
                <c:formatCode>0.00</c:formatCode>
                <c:ptCount val="5"/>
                <c:pt idx="0">
                  <c:v>0.60404624277456664</c:v>
                </c:pt>
                <c:pt idx="1">
                  <c:v>0.97760115606936515</c:v>
                </c:pt>
                <c:pt idx="2">
                  <c:v>0.52890173410404662</c:v>
                </c:pt>
                <c:pt idx="3">
                  <c:v>0.70231213872832221</c:v>
                </c:pt>
                <c:pt idx="4">
                  <c:v>1.0426300578034657</c:v>
                </c:pt>
              </c:numCache>
            </c:numRef>
          </c:val>
        </c:ser>
        <c:axId val="82015360"/>
        <c:axId val="89307008"/>
      </c:barChart>
      <c:catAx>
        <c:axId val="82015360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9307008"/>
        <c:crosses val="autoZero"/>
        <c:auto val="1"/>
        <c:lblAlgn val="ctr"/>
        <c:lblOffset val="100"/>
      </c:catAx>
      <c:valAx>
        <c:axId val="8930700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ES" sz="1200" dirty="0" err="1">
                    <a:latin typeface="Arial" pitchFamily="34" charset="0"/>
                    <a:cs typeface="Arial" pitchFamily="34" charset="0"/>
                  </a:rPr>
                  <a:t>Relative</a:t>
                </a:r>
                <a:r>
                  <a:rPr lang="es-ES" sz="1200" baseline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200" baseline="0" dirty="0" err="1" smtClean="0">
                    <a:latin typeface="Arial" pitchFamily="34" charset="0"/>
                    <a:cs typeface="Arial" pitchFamily="34" charset="0"/>
                  </a:rPr>
                  <a:t>biomass</a:t>
                </a:r>
                <a:endParaRPr lang="es-ES" sz="1200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</c:title>
        <c:numFmt formatCode="0.0" sourceLinked="0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2015360"/>
        <c:crosses val="autoZero"/>
        <c:crossBetween val="between"/>
      </c:valAx>
    </c:plotArea>
    <c:plotVisOnly val="1"/>
  </c:chart>
  <c:spPr>
    <a:solidFill>
      <a:schemeClr val="bg1"/>
    </a:solidFill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ES_tradnl"/>
  <c:chart>
    <c:plotArea>
      <c:layout>
        <c:manualLayout>
          <c:layoutTarget val="inner"/>
          <c:xMode val="edge"/>
          <c:yMode val="edge"/>
          <c:x val="0.16132632023026203"/>
          <c:y val="4.4858679665530803E-2"/>
          <c:w val="0.74745570905558401"/>
          <c:h val="0.74860659188131429"/>
        </c:manualLayout>
      </c:layout>
      <c:barChart>
        <c:barDir val="col"/>
        <c:grouping val="clustered"/>
        <c:ser>
          <c:idx val="0"/>
          <c:order val="0"/>
          <c:tx>
            <c:v>24 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1!$D$34:$D$38</c:f>
              <c:strCache>
                <c:ptCount val="5"/>
                <c:pt idx="0">
                  <c:v>PFK26</c:v>
                </c:pt>
                <c:pt idx="1">
                  <c:v>POT1</c:v>
                </c:pt>
                <c:pt idx="2">
                  <c:v>MNI1</c:v>
                </c:pt>
                <c:pt idx="3">
                  <c:v>YIA6</c:v>
                </c:pt>
                <c:pt idx="4">
                  <c:v>URE2</c:v>
                </c:pt>
              </c:strCache>
            </c:strRef>
          </c:cat>
          <c:val>
            <c:numRef>
              <c:f>Sheet1!$E$34:$E$38</c:f>
              <c:numCache>
                <c:formatCode>0.00</c:formatCode>
                <c:ptCount val="5"/>
                <c:pt idx="0">
                  <c:v>0.84529147982062791</c:v>
                </c:pt>
                <c:pt idx="1">
                  <c:v>0.89461883408071763</c:v>
                </c:pt>
                <c:pt idx="2">
                  <c:v>0.83183856502242159</c:v>
                </c:pt>
                <c:pt idx="3">
                  <c:v>0.87668161434977987</c:v>
                </c:pt>
                <c:pt idx="4">
                  <c:v>0.8565022421524664</c:v>
                </c:pt>
              </c:numCache>
            </c:numRef>
          </c:val>
        </c:ser>
        <c:ser>
          <c:idx val="1"/>
          <c:order val="1"/>
          <c:tx>
            <c:v>21 days</c:v>
          </c:tx>
          <c:spPr>
            <a:solidFill>
              <a:schemeClr val="tx1"/>
            </a:solidFill>
          </c:spPr>
          <c:cat>
            <c:strRef>
              <c:f>Sheet1!$D$34:$D$38</c:f>
              <c:strCache>
                <c:ptCount val="5"/>
                <c:pt idx="0">
                  <c:v>PFK26</c:v>
                </c:pt>
                <c:pt idx="1">
                  <c:v>POT1</c:v>
                </c:pt>
                <c:pt idx="2">
                  <c:v>MNI1</c:v>
                </c:pt>
                <c:pt idx="3">
                  <c:v>YIA6</c:v>
                </c:pt>
                <c:pt idx="4">
                  <c:v>URE2</c:v>
                </c:pt>
              </c:strCache>
            </c:strRef>
          </c:cat>
          <c:val>
            <c:numRef>
              <c:f>Sheet1!$F$34:$F$38</c:f>
              <c:numCache>
                <c:formatCode>0.00</c:formatCode>
                <c:ptCount val="5"/>
                <c:pt idx="0">
                  <c:v>1.0397398843930636</c:v>
                </c:pt>
                <c:pt idx="1">
                  <c:v>0.91184971098265899</c:v>
                </c:pt>
                <c:pt idx="2">
                  <c:v>1.0859826589595376</c:v>
                </c:pt>
                <c:pt idx="3">
                  <c:v>1.0050578034682112</c:v>
                </c:pt>
                <c:pt idx="4">
                  <c:v>1.013728323699419</c:v>
                </c:pt>
              </c:numCache>
            </c:numRef>
          </c:val>
        </c:ser>
        <c:axId val="84194048"/>
        <c:axId val="84195584"/>
      </c:barChart>
      <c:catAx>
        <c:axId val="84194048"/>
        <c:scaling>
          <c:orientation val="minMax"/>
        </c:scaling>
        <c:axPos val="b"/>
        <c:tickLblPos val="nextTo"/>
        <c:txPr>
          <a:bodyPr rot="-2700000"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4195584"/>
        <c:crosses val="autoZero"/>
        <c:auto val="1"/>
        <c:lblAlgn val="ctr"/>
        <c:lblOffset val="100"/>
      </c:catAx>
      <c:valAx>
        <c:axId val="8419558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ES" sz="1200" dirty="0" err="1">
                    <a:latin typeface="Arial" pitchFamily="34" charset="0"/>
                    <a:cs typeface="Arial" pitchFamily="34" charset="0"/>
                  </a:rPr>
                  <a:t>Relative</a:t>
                </a:r>
                <a:r>
                  <a:rPr lang="es-ES" sz="1200" baseline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200" baseline="0" dirty="0" err="1" smtClean="0">
                    <a:latin typeface="Arial" pitchFamily="34" charset="0"/>
                    <a:cs typeface="Arial" pitchFamily="34" charset="0"/>
                  </a:rPr>
                  <a:t>biomass</a:t>
                </a:r>
                <a:endParaRPr lang="es-ES" sz="1200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</c:title>
        <c:numFmt formatCode="0.0" sourceLinked="0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ES_tradnl"/>
          </a:p>
        </c:txPr>
        <c:crossAx val="84194048"/>
        <c:crosses val="autoZero"/>
        <c:crossBetween val="between"/>
      </c:valAx>
    </c:plotArea>
    <c:plotVisOnly val="1"/>
  </c:chart>
  <c:spPr>
    <a:solidFill>
      <a:schemeClr val="bg1"/>
    </a:solidFill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61631" y="2130427"/>
            <a:ext cx="7498477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23261" y="3886200"/>
            <a:ext cx="6175217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14082" y="274639"/>
            <a:ext cx="2735351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8027" y="274639"/>
            <a:ext cx="8059025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96857" y="4406902"/>
            <a:ext cx="7498477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96857" y="2906713"/>
            <a:ext cx="7498477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8027" y="1600202"/>
            <a:ext cx="539718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52243" y="1600202"/>
            <a:ext cx="539718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41087" y="274638"/>
            <a:ext cx="7939565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41087" y="1535113"/>
            <a:ext cx="38978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41087" y="2174875"/>
            <a:ext cx="38978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481321" y="1535113"/>
            <a:ext cx="389933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481321" y="2174875"/>
            <a:ext cx="389933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41088" y="273050"/>
            <a:ext cx="290229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449055" y="273052"/>
            <a:ext cx="493159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41088" y="1435102"/>
            <a:ext cx="290229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29123" y="4800600"/>
            <a:ext cx="5293043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29123" y="612775"/>
            <a:ext cx="5293043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29123" y="5367338"/>
            <a:ext cx="5293043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41087" y="274638"/>
            <a:ext cx="793956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41087" y="1600202"/>
            <a:ext cx="793956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41086" y="6356352"/>
            <a:ext cx="205840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7066E5-E7EC-40F0-A839-080A2B137E56}" type="datetimeFigureOut">
              <a:rPr lang="es-ES" smtClean="0"/>
              <a:pPr/>
              <a:t>23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014094" y="6356352"/>
            <a:ext cx="279355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322246" y="6356352"/>
            <a:ext cx="205840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C8851-04B6-4CCD-86C1-522AA5E6B9CA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>
            <a:grpSpLocks noChangeAspect="1"/>
          </p:cNvGrpSpPr>
          <p:nvPr/>
        </p:nvGrpSpPr>
        <p:grpSpPr>
          <a:xfrm>
            <a:off x="1170509" y="692696"/>
            <a:ext cx="6336704" cy="3656355"/>
            <a:chOff x="1170509" y="1639833"/>
            <a:chExt cx="6345404" cy="3661375"/>
          </a:xfrm>
        </p:grpSpPr>
        <p:graphicFrame>
          <p:nvGraphicFramePr>
            <p:cNvPr id="6" name="16 Gráfico"/>
            <p:cNvGraphicFramePr/>
            <p:nvPr/>
          </p:nvGraphicFramePr>
          <p:xfrm>
            <a:off x="1242517" y="1857376"/>
            <a:ext cx="3244908" cy="34438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7 CuadroTexto"/>
            <p:cNvSpPr txBox="1"/>
            <p:nvPr/>
          </p:nvSpPr>
          <p:spPr>
            <a:xfrm>
              <a:off x="1170509" y="1643058"/>
              <a:ext cx="3528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s-E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4122837" y="1639833"/>
              <a:ext cx="3528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s-ES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7" name="16 Gráfico"/>
            <p:cNvGraphicFramePr/>
            <p:nvPr/>
          </p:nvGraphicFramePr>
          <p:xfrm>
            <a:off x="4415318" y="1845105"/>
            <a:ext cx="3100595" cy="34438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11" name="Rectangle 10"/>
          <p:cNvSpPr/>
          <p:nvPr/>
        </p:nvSpPr>
        <p:spPr>
          <a:xfrm>
            <a:off x="899592" y="4437112"/>
            <a:ext cx="763284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lnSpc>
                <a:spcPct val="150000"/>
              </a:lnSpc>
            </a:pPr>
            <a:r>
              <a:rPr lang="en-US" sz="1200" b="1" dirty="0" smtClean="0">
                <a:latin typeface="Arial"/>
              </a:rPr>
              <a:t>Figure S4: </a:t>
            </a:r>
            <a:r>
              <a:rPr lang="en-US" sz="1200" dirty="0" smtClean="0">
                <a:latin typeface="Arial"/>
              </a:rPr>
              <a:t>Relative biomass observed after 24 h (white bars) or after fermentation arrest (black bars) for strains identified under Phase I (panel A) and Phase II (panel B) conditions by inverse HOP analyses. Relative biomass after 24 h was estimated by comparing turbidity of the indicated strains with the control strain (BY4743) in the same batch. It was measured as NTUs with a 2100N </a:t>
            </a:r>
            <a:r>
              <a:rPr lang="en-US" sz="1200" dirty="0" err="1" smtClean="0">
                <a:latin typeface="Arial"/>
              </a:rPr>
              <a:t>Turbidimeter</a:t>
            </a:r>
            <a:r>
              <a:rPr lang="en-US" sz="1200" dirty="0" smtClean="0">
                <a:latin typeface="Arial"/>
              </a:rPr>
              <a:t> (HASH, Loveland. CO). Relative biomass after 21 days was estimated by measuring OD600 of the </a:t>
            </a:r>
            <a:r>
              <a:rPr lang="en-US" sz="1200" smtClean="0">
                <a:latin typeface="Arial"/>
              </a:rPr>
              <a:t>homogenized culture and </a:t>
            </a:r>
            <a:r>
              <a:rPr lang="en-US" sz="1200" dirty="0" smtClean="0">
                <a:latin typeface="Arial"/>
              </a:rPr>
              <a:t>comparing </a:t>
            </a:r>
            <a:r>
              <a:rPr lang="en-US" sz="1200" smtClean="0">
                <a:latin typeface="Arial"/>
              </a:rPr>
              <a:t>data </a:t>
            </a:r>
            <a:r>
              <a:rPr lang="en-US" sz="1200" smtClean="0">
                <a:latin typeface="Arial"/>
              </a:rPr>
              <a:t>from </a:t>
            </a:r>
            <a:r>
              <a:rPr lang="en-US" sz="1200" dirty="0" smtClean="0">
                <a:latin typeface="Arial"/>
              </a:rPr>
              <a:t>the deleted strains with those of the control strain (BY4743) in the same batch. Stars indicate statistically significant differences between BY4743 and the deleted strain.</a:t>
            </a:r>
            <a:endParaRPr lang="en-US" sz="2400" b="1" dirty="0">
              <a:latin typeface="Times New Roman"/>
            </a:endParaRPr>
          </a:p>
        </p:txBody>
      </p:sp>
      <p:sp>
        <p:nvSpPr>
          <p:cNvPr id="12" name="TextBox 32"/>
          <p:cNvSpPr txBox="1"/>
          <p:nvPr/>
        </p:nvSpPr>
        <p:spPr>
          <a:xfrm>
            <a:off x="1818581" y="1650866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3" name="TextBox 32"/>
          <p:cNvSpPr txBox="1"/>
          <p:nvPr/>
        </p:nvSpPr>
        <p:spPr>
          <a:xfrm>
            <a:off x="1970981" y="2196480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4" name="TextBox 32"/>
          <p:cNvSpPr txBox="1"/>
          <p:nvPr/>
        </p:nvSpPr>
        <p:spPr>
          <a:xfrm>
            <a:off x="2250629" y="1423809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5" name="TextBox 32"/>
          <p:cNvSpPr txBox="1"/>
          <p:nvPr/>
        </p:nvSpPr>
        <p:spPr>
          <a:xfrm>
            <a:off x="2682677" y="1855857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6" name="TextBox 32"/>
          <p:cNvSpPr txBox="1"/>
          <p:nvPr/>
        </p:nvSpPr>
        <p:spPr>
          <a:xfrm>
            <a:off x="2835077" y="2351529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7" name="TextBox 32"/>
          <p:cNvSpPr txBox="1"/>
          <p:nvPr/>
        </p:nvSpPr>
        <p:spPr>
          <a:xfrm>
            <a:off x="3174683" y="1855857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8" name="TextBox 32"/>
          <p:cNvSpPr txBox="1"/>
          <p:nvPr/>
        </p:nvSpPr>
        <p:spPr>
          <a:xfrm>
            <a:off x="3318699" y="1927865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19" name="TextBox 32"/>
          <p:cNvSpPr txBox="1"/>
          <p:nvPr/>
        </p:nvSpPr>
        <p:spPr>
          <a:xfrm>
            <a:off x="3606731" y="1639833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20" name="TextBox 32"/>
          <p:cNvSpPr txBox="1"/>
          <p:nvPr/>
        </p:nvSpPr>
        <p:spPr>
          <a:xfrm>
            <a:off x="4974883" y="1567825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21" name="TextBox 32"/>
          <p:cNvSpPr txBox="1"/>
          <p:nvPr/>
        </p:nvSpPr>
        <p:spPr>
          <a:xfrm>
            <a:off x="5406931" y="1495817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22" name="TextBox 32"/>
          <p:cNvSpPr txBox="1"/>
          <p:nvPr/>
        </p:nvSpPr>
        <p:spPr>
          <a:xfrm>
            <a:off x="5851029" y="1639833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23" name="TextBox 32"/>
          <p:cNvSpPr txBox="1"/>
          <p:nvPr/>
        </p:nvSpPr>
        <p:spPr>
          <a:xfrm>
            <a:off x="6343035" y="1506850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  <p:sp>
        <p:nvSpPr>
          <p:cNvPr id="24" name="TextBox 32"/>
          <p:cNvSpPr txBox="1"/>
          <p:nvPr/>
        </p:nvSpPr>
        <p:spPr>
          <a:xfrm>
            <a:off x="6787133" y="1578858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38694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77388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16081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54775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693469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32163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370856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09550" algn="l" defTabSz="677388" rtl="0" eaLnBrk="1" latinLnBrk="0" hangingPunct="1"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1200" dirty="0" smtClean="0"/>
              <a:t>*</a:t>
            </a:r>
            <a:endParaRPr lang="es-ES_tradnl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152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nolo</dc:creator>
  <cp:lastModifiedBy>Pilar y Ramón</cp:lastModifiedBy>
  <cp:revision>16</cp:revision>
  <dcterms:created xsi:type="dcterms:W3CDTF">2013-03-12T00:00:21Z</dcterms:created>
  <dcterms:modified xsi:type="dcterms:W3CDTF">2013-06-23T09:27:19Z</dcterms:modified>
</cp:coreProperties>
</file>